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14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151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80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023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879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932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135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736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815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967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809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38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73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573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="" xmlns:a16="http://schemas.microsoft.com/office/drawing/2014/main" id="{59936FB1-B823-4128-883E-098837DB0779}"/>
              </a:ext>
            </a:extLst>
          </p:cNvPr>
          <p:cNvGrpSpPr/>
          <p:nvPr/>
        </p:nvGrpSpPr>
        <p:grpSpPr>
          <a:xfrm>
            <a:off x="23445" y="582602"/>
            <a:ext cx="8530592" cy="6243531"/>
            <a:chOff x="23445" y="582602"/>
            <a:chExt cx="8530592" cy="6243531"/>
          </a:xfrm>
        </p:grpSpPr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6942083F-F77F-427C-85DD-B84C61D176C4}"/>
                </a:ext>
              </a:extLst>
            </p:cNvPr>
            <p:cNvSpPr txBox="1"/>
            <p:nvPr/>
          </p:nvSpPr>
          <p:spPr>
            <a:xfrm>
              <a:off x="23445" y="6487579"/>
              <a:ext cx="9598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600" b="1"/>
              </a:lvl1pPr>
            </a:lstStyle>
            <a:p>
              <a:r>
                <a:rPr lang="en-US"/>
                <a:t>Figure </a:t>
              </a:r>
              <a:r>
                <a:rPr lang="en-US" smtClean="0"/>
                <a:t>S2</a:t>
              </a:r>
              <a:endParaRPr lang="en-US" dirty="0"/>
            </a:p>
          </p:txBody>
        </p:sp>
        <p:grpSp>
          <p:nvGrpSpPr>
            <p:cNvPr id="6" name="Group 5">
              <a:extLst>
                <a:ext uri="{FF2B5EF4-FFF2-40B4-BE49-F238E27FC236}">
                  <a16:creationId xmlns="" xmlns:a16="http://schemas.microsoft.com/office/drawing/2014/main" id="{82543799-F029-439F-85D7-CDF366D54F59}"/>
                </a:ext>
              </a:extLst>
            </p:cNvPr>
            <p:cNvGrpSpPr/>
            <p:nvPr/>
          </p:nvGrpSpPr>
          <p:grpSpPr>
            <a:xfrm>
              <a:off x="503352" y="582602"/>
              <a:ext cx="3877521" cy="2479335"/>
              <a:chOff x="503352" y="582602"/>
              <a:chExt cx="3877521" cy="2479335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="" xmlns:a16="http://schemas.microsoft.com/office/drawing/2014/main" id="{AD2B8B3C-1D03-4DA8-8176-EACEEA1D0459}"/>
                  </a:ext>
                </a:extLst>
              </p:cNvPr>
              <p:cNvGrpSpPr/>
              <p:nvPr/>
            </p:nvGrpSpPr>
            <p:grpSpPr>
              <a:xfrm>
                <a:off x="503352" y="582602"/>
                <a:ext cx="3877521" cy="2479335"/>
                <a:chOff x="851372" y="327198"/>
                <a:chExt cx="3877521" cy="2479335"/>
              </a:xfrm>
            </p:grpSpPr>
            <p:sp>
              <p:nvSpPr>
                <p:cNvPr id="14" name="TextBox 13">
                  <a:extLst>
                    <a:ext uri="{FF2B5EF4-FFF2-40B4-BE49-F238E27FC236}">
                      <a16:creationId xmlns="" xmlns:a16="http://schemas.microsoft.com/office/drawing/2014/main" id="{A9B701EF-4BEA-4DE0-86D7-5296E34124DC}"/>
                    </a:ext>
                  </a:extLst>
                </p:cNvPr>
                <p:cNvSpPr txBox="1"/>
                <p:nvPr/>
              </p:nvSpPr>
              <p:spPr>
                <a:xfrm>
                  <a:off x="851372" y="360842"/>
                  <a:ext cx="105509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Non-Specific IgG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="" xmlns:a16="http://schemas.microsoft.com/office/drawing/2014/main" id="{13D3D200-3791-42E8-AC1C-3926A642DF51}"/>
                    </a:ext>
                  </a:extLst>
                </p:cNvPr>
                <p:cNvSpPr txBox="1"/>
                <p:nvPr/>
              </p:nvSpPr>
              <p:spPr>
                <a:xfrm>
                  <a:off x="3729902" y="972839"/>
                  <a:ext cx="99899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Before Exercise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="" xmlns:a16="http://schemas.microsoft.com/office/drawing/2014/main" id="{9EE06B9C-0AB4-4B00-937A-2AF671EE95E6}"/>
                    </a:ext>
                  </a:extLst>
                </p:cNvPr>
                <p:cNvSpPr txBox="1"/>
                <p:nvPr/>
              </p:nvSpPr>
              <p:spPr>
                <a:xfrm>
                  <a:off x="3723174" y="1958403"/>
                  <a:ext cx="91563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After Exercise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="" xmlns:a16="http://schemas.microsoft.com/office/drawing/2014/main" id="{9AC42A15-9C9F-41D4-9B10-1B9EAE910E7B}"/>
                    </a:ext>
                  </a:extLst>
                </p:cNvPr>
                <p:cNvSpPr txBox="1"/>
                <p:nvPr/>
              </p:nvSpPr>
              <p:spPr>
                <a:xfrm>
                  <a:off x="2978157" y="2560312"/>
                  <a:ext cx="62228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Diabetic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="" xmlns:a16="http://schemas.microsoft.com/office/drawing/2014/main" id="{88BB530B-7ECE-4899-AB4D-011A2F2134DF}"/>
                    </a:ext>
                  </a:extLst>
                </p:cNvPr>
                <p:cNvSpPr txBox="1"/>
                <p:nvPr/>
              </p:nvSpPr>
              <p:spPr>
                <a:xfrm>
                  <a:off x="1814249" y="2560312"/>
                  <a:ext cx="91242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Non- Diabetic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="" xmlns:a16="http://schemas.microsoft.com/office/drawing/2014/main" id="{CFA4C33E-CF7A-47FF-B260-50D2C73ADE77}"/>
                    </a:ext>
                  </a:extLst>
                </p:cNvPr>
                <p:cNvSpPr txBox="1"/>
                <p:nvPr/>
              </p:nvSpPr>
              <p:spPr>
                <a:xfrm>
                  <a:off x="2399889" y="327198"/>
                  <a:ext cx="103746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Adiponectin IgG</a:t>
                  </a:r>
                </a:p>
              </p:txBody>
            </p:sp>
            <p:cxnSp>
              <p:nvCxnSpPr>
                <p:cNvPr id="25" name="Straight Connector 24">
                  <a:extLst>
                    <a:ext uri="{FF2B5EF4-FFF2-40B4-BE49-F238E27FC236}">
                      <a16:creationId xmlns="" xmlns:a16="http://schemas.microsoft.com/office/drawing/2014/main" id="{CFAA1788-6DDE-4343-8DFA-EFDA3777B4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824503" y="573419"/>
                  <a:ext cx="198882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5" name="Picture 4">
                <a:extLst>
                  <a:ext uri="{FF2B5EF4-FFF2-40B4-BE49-F238E27FC236}">
                    <a16:creationId xmlns="" xmlns:a16="http://schemas.microsoft.com/office/drawing/2014/main" id="{160CB9F2-573C-4A18-BBEB-541759C04A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06751" y="875879"/>
                <a:ext cx="2926334" cy="1950889"/>
              </a:xfrm>
              <a:prstGeom prst="rect">
                <a:avLst/>
              </a:prstGeom>
            </p:spPr>
          </p:pic>
        </p:grpSp>
        <p:pic>
          <p:nvPicPr>
            <p:cNvPr id="15" name="Picture 3">
              <a:extLst>
                <a:ext uri="{FF2B5EF4-FFF2-40B4-BE49-F238E27FC236}">
                  <a16:creationId xmlns="" xmlns:a16="http://schemas.microsoft.com/office/drawing/2014/main" id="{27B52E97-EB20-4B80-8471-52BC4A786B5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332046" y="627180"/>
              <a:ext cx="3221991" cy="28350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extLst>
      <p:ext uri="{BB962C8B-B14F-4D97-AF65-F5344CB8AC3E}">
        <p14:creationId xmlns:p14="http://schemas.microsoft.com/office/powerpoint/2010/main" val="1755784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309</TotalTime>
  <Words>13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elkrim Khadir</dc:creator>
  <cp:lastModifiedBy>DBALINDAN</cp:lastModifiedBy>
  <cp:revision>164</cp:revision>
  <cp:lastPrinted>2018-05-28T06:54:59Z</cp:lastPrinted>
  <dcterms:created xsi:type="dcterms:W3CDTF">2017-11-22T07:43:06Z</dcterms:created>
  <dcterms:modified xsi:type="dcterms:W3CDTF">2018-11-23T05:08:29Z</dcterms:modified>
</cp:coreProperties>
</file>